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82" r:id="rId4"/>
    <p:sldId id="275" r:id="rId5"/>
    <p:sldId id="260" r:id="rId6"/>
    <p:sldId id="261" r:id="rId7"/>
    <p:sldId id="277" r:id="rId8"/>
    <p:sldId id="262" r:id="rId9"/>
    <p:sldId id="281" r:id="rId10"/>
    <p:sldId id="263" r:id="rId11"/>
    <p:sldId id="280" r:id="rId12"/>
    <p:sldId id="278" r:id="rId13"/>
    <p:sldId id="264" r:id="rId14"/>
    <p:sldId id="265" r:id="rId15"/>
    <p:sldId id="266" r:id="rId16"/>
    <p:sldId id="267" r:id="rId17"/>
    <p:sldId id="268" r:id="rId18"/>
    <p:sldId id="269" r:id="rId19"/>
    <p:sldId id="283" r:id="rId20"/>
    <p:sldId id="270" r:id="rId21"/>
    <p:sldId id="276" r:id="rId22"/>
    <p:sldId id="271" r:id="rId23"/>
    <p:sldId id="272" r:id="rId24"/>
    <p:sldId id="279" r:id="rId25"/>
    <p:sldId id="273" r:id="rId26"/>
    <p:sldId id="274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6F872-430B-1008-AD17-A4BC97DBF7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55CB05-8DBE-18AD-955A-0B3F63F072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BFBC5-B996-7126-24AE-429DEA96C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C992C-945D-A816-F483-0CE0943AF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B673A6-F65B-9B27-3C25-6044A7D2B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94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B839-0224-F018-AEC6-0CF1FF00C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52659D-C284-5B48-7239-F0F4793595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8E6A3-569A-705D-9349-C61C5474FB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EE2D7-0F01-749C-1F04-3DB5ECAB3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9764D-952B-5676-6777-84F91C44B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749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BB1D5C-6E9D-92BA-06B8-B1623755C7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AE9B15-C608-D758-0C8E-1003175DDF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C4E0D-593D-51D5-1416-1640F235F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44670-3B48-6665-50B2-CF72B5918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BE4586-5F1D-A899-5D19-E9F03B025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320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B33CA-2201-9CF7-89F6-2DB9FC3AB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6DD6F2-EC7D-CAFF-1277-2F5CE3650E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43205-DB9C-2BF2-2788-A3004BE79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E417E-DEE6-665A-3E5B-DBEA61568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A7EFBE-9BA6-88E1-5CED-82970A089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85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62FFEE-5D1F-AC85-BE02-6E3472DCE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6AD483-A53F-6F86-244E-66BDD6A4BA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0E031A-C50B-D640-8B26-35A4AF307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489225-6E6F-061E-C744-B2DDA5D74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0FF46D-8E75-C56B-4E9F-F167933DA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663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AFFD4-6888-B37F-BCA4-2379A3B12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A448EC-3052-9697-B5BD-A1085D32A0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C6F9B6-0EAE-0A32-06B9-E5DD32BC32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B8EAD2-1D10-3934-0011-27B1A16B8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67BA00-63F1-39C3-DCE3-679E66971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73554F-430C-8FE9-B775-683902013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836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3A6B9-07E0-5E5A-A644-A2619960C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34A0B1-524F-BB18-1032-FA34F27A5A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4AB9DA-ED0E-6DED-DE3D-8D8063C827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2F0CF4-E15F-242B-D28B-BF26A90D71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8DE793-4E70-B3A6-5F0E-B0359CF22E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42A77C-82F6-2E3E-4428-40B135978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F63A81-27A9-892B-4489-1E33E70213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76038B-1A2C-67C5-8CB8-4004B4099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978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E8AEF2-1EDF-26C3-828F-EFA195CFA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82EBE3-5472-CA92-75FD-F9E4A48D9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2EA603-F92C-A367-06F9-9B1C5C95C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68C8E2-3D3B-81F3-4CBA-7708B3C07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462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BCA4FB-54D7-DD07-D914-889E82B28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742F87-064A-9385-B558-CDA2EFF35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0603D9-D6A0-ED4E-508E-9B540ECC3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333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69B00-EE48-B7EF-01F7-5E1EE40627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FF383C-42EB-47B6-E0C0-EAD6ED6C19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27F1A3-F622-2586-2459-ABB9AEAA0F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E4ABC2-A7E9-6426-B1C4-479A0C9B2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686052-2B31-097A-96C4-1382E2C87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60C0F7-07B4-B3CA-370D-6A65895DD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63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B0B2A-8EE3-F43A-9DD8-3907DE7CC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105EFA-C063-2D2F-0447-AD8D8F238E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2ABB11-5DB7-F114-D23D-4A3E054C0C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D2235C-4BD2-79E7-1F08-5607D0963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39541D-1C5C-F2D9-82DD-6D41BE7CD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4E4A11-9DD2-A74D-4331-2B45D65AD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154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F1A2E0-9FB0-A4DC-CC07-848D41BA24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9120F4-E695-B3C5-D148-A84E46E245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B4FAA-D24D-CFE1-21AA-5EEA20B215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6C5AB6-96A8-4D45-B54B-B40818C875B1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46F173-0F41-13AA-EFA8-E74472C28C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7FFCF7-1A08-58BA-3D22-AEF89A8027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0AE6FE-8B14-4586-9B27-7D9D7E16D9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272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74B182CD-825A-C161-ED57-9F82DC8EE39A}"/>
              </a:ext>
            </a:extLst>
          </p:cNvPr>
          <p:cNvSpPr txBox="1">
            <a:spLocks/>
          </p:cNvSpPr>
          <p:nvPr/>
        </p:nvSpPr>
        <p:spPr>
          <a:xfrm>
            <a:off x="2778054" y="40015"/>
            <a:ext cx="6431530" cy="826656"/>
          </a:xfrm>
          <a:prstGeom prst="rect">
            <a:avLst/>
          </a:prstGeom>
        </p:spPr>
        <p:txBody>
          <a:bodyPr>
            <a:normAutofit fontScale="92500"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</a:p>
          <a:p>
            <a:pPr algn="ctr">
              <a:lnSpc>
                <a:spcPct val="100000"/>
              </a:lnSpc>
              <a:spcAft>
                <a:spcPts val="600"/>
              </a:spcAft>
            </a:pPr>
            <a:r>
              <a:rPr lang="en-US" sz="2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IL-17F/IL-17RA (3jvf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6C7819-AF92-41DC-B10C-882BC26FC083}"/>
              </a:ext>
            </a:extLst>
          </p:cNvPr>
          <p:cNvSpPr txBox="1"/>
          <p:nvPr/>
        </p:nvSpPr>
        <p:spPr>
          <a:xfrm>
            <a:off x="526651" y="1035586"/>
            <a:ext cx="107009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6 showing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mary of drug docking human IL-17F/IL-17RA (3jvf) via binding to critical residues for binding and glycosylation.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7DC53EF-BE59-FEBE-F181-62D10AC1E7EA}"/>
              </a:ext>
            </a:extLst>
          </p:cNvPr>
          <p:cNvSpPr txBox="1">
            <a:spLocks/>
          </p:cNvSpPr>
          <p:nvPr/>
        </p:nvSpPr>
        <p:spPr>
          <a:xfrm>
            <a:off x="-2351707" y="622258"/>
            <a:ext cx="10454640" cy="826656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endParaRPr lang="en-US" sz="32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1211513-0C28-D544-9DE3-A3A99EF615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6338829"/>
              </p:ext>
            </p:extLst>
          </p:nvPr>
        </p:nvGraphicFramePr>
        <p:xfrm>
          <a:off x="3762531" y="1617829"/>
          <a:ext cx="7115594" cy="522949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270463">
                  <a:extLst>
                    <a:ext uri="{9D8B030D-6E8A-4147-A177-3AD203B41FA5}">
                      <a16:colId xmlns:a16="http://schemas.microsoft.com/office/drawing/2014/main" val="2691693849"/>
                    </a:ext>
                  </a:extLst>
                </a:gridCol>
                <a:gridCol w="2565069">
                  <a:extLst>
                    <a:ext uri="{9D8B030D-6E8A-4147-A177-3AD203B41FA5}">
                      <a16:colId xmlns:a16="http://schemas.microsoft.com/office/drawing/2014/main" val="225508581"/>
                    </a:ext>
                  </a:extLst>
                </a:gridCol>
                <a:gridCol w="2280062">
                  <a:extLst>
                    <a:ext uri="{9D8B030D-6E8A-4147-A177-3AD203B41FA5}">
                      <a16:colId xmlns:a16="http://schemas.microsoft.com/office/drawing/2014/main" val="657043800"/>
                    </a:ext>
                  </a:extLst>
                </a:gridCol>
              </a:tblGrid>
              <a:tr h="48710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of IL-17F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ed critical residues of IL-17RA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6030728"/>
                  </a:ext>
                </a:extLst>
              </a:tr>
              <a:tr h="30848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ygdal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42 and Cys72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59, Leu260, Asn261, Asp262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0235878"/>
                  </a:ext>
                </a:extLst>
              </a:tr>
              <a:tr h="303243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itriol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72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59, Leu260, Asn261, Asp262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5405714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mdesivir 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79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n211, His212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930977"/>
                  </a:ext>
                </a:extLst>
              </a:tr>
              <a:tr h="202707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Nitazoxanide</a:t>
                      </a: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7875722"/>
                  </a:ext>
                </a:extLst>
              </a:tr>
              <a:tr h="18262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examethasone</a:t>
                      </a: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ys154, Cys259, Cys263</a:t>
                      </a: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0435887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isqualic 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g42 and Arg47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59, Cys263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9375581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minopterin</a:t>
                      </a: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906066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inapril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12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5417441"/>
                  </a:ext>
                </a:extLst>
              </a:tr>
              <a:tr h="10796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emisinin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s245, Cys246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73394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minopterin</a:t>
                      </a: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ys154</a:t>
                      </a: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51880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sidomi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9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60 and Arg102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9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31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103779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et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1392052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igen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9876667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n 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6838083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ercet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484601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moquino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63128995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ptanthr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62201521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ulic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8021152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rubin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3505343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quinolo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60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668214"/>
                  </a:ext>
                </a:extLst>
              </a:tr>
              <a:tr h="215929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ionine sulfoximine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5620" marR="65620" marT="9286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04169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691914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3A9F4FB1-154D-78C4-6C6F-143AA13896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8966" y="747338"/>
            <a:ext cx="9974067" cy="536332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B2EFCEB-E9C2-DAED-74D5-49B04CFF15CC}"/>
              </a:ext>
            </a:extLst>
          </p:cNvPr>
          <p:cNvSpPr/>
          <p:nvPr/>
        </p:nvSpPr>
        <p:spPr>
          <a:xfrm>
            <a:off x="1135847" y="6110661"/>
            <a:ext cx="918713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i: Coumarin docking IL-17/IL-17R (3jvf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AEFC3F61-1CB6-3357-5E4D-94483347C5A1}"/>
              </a:ext>
            </a:extLst>
          </p:cNvPr>
          <p:cNvSpPr/>
          <p:nvPr/>
        </p:nvSpPr>
        <p:spPr>
          <a:xfrm rot="4081701">
            <a:off x="7215209" y="169440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2DFA7575-E2F6-123A-D469-31FC818377F2}"/>
              </a:ext>
            </a:extLst>
          </p:cNvPr>
          <p:cNvSpPr/>
          <p:nvPr/>
        </p:nvSpPr>
        <p:spPr>
          <a:xfrm rot="15795605">
            <a:off x="7611817" y="4527248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DFE00C42-59AA-0BE7-C75D-C6927D20FACA}"/>
              </a:ext>
            </a:extLst>
          </p:cNvPr>
          <p:cNvSpPr/>
          <p:nvPr/>
        </p:nvSpPr>
        <p:spPr>
          <a:xfrm rot="15795605">
            <a:off x="9593017" y="4712080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7601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30C3B5D-5D3B-982C-FD1C-75A32B20E75D}"/>
              </a:ext>
            </a:extLst>
          </p:cNvPr>
          <p:cNvSpPr/>
          <p:nvPr/>
        </p:nvSpPr>
        <p:spPr>
          <a:xfrm>
            <a:off x="545943" y="6110661"/>
            <a:ext cx="1036694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j: Dexamethasone docking IL-17/IL-17R (3jvf)</a:t>
            </a:r>
          </a:p>
        </p:txBody>
      </p:sp>
      <p:pic>
        <p:nvPicPr>
          <p:cNvPr id="5" name="Picture 4" descr="A close-up of a structure&#10;&#10;AI-generated content may be incorrect.">
            <a:extLst>
              <a:ext uri="{FF2B5EF4-FFF2-40B4-BE49-F238E27FC236}">
                <a16:creationId xmlns:a16="http://schemas.microsoft.com/office/drawing/2014/main" id="{8966038D-1FCE-7B52-D034-B764782288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0248" y="878867"/>
            <a:ext cx="9059361" cy="4798827"/>
          </a:xfrm>
          <a:prstGeom prst="rect">
            <a:avLst/>
          </a:prstGeom>
        </p:spPr>
      </p:pic>
      <p:sp>
        <p:nvSpPr>
          <p:cNvPr id="2" name="Arrow: Right 1">
            <a:extLst>
              <a:ext uri="{FF2B5EF4-FFF2-40B4-BE49-F238E27FC236}">
                <a16:creationId xmlns:a16="http://schemas.microsoft.com/office/drawing/2014/main" id="{1872E0A2-D92E-03B1-25EE-80619CB83828}"/>
              </a:ext>
            </a:extLst>
          </p:cNvPr>
          <p:cNvSpPr/>
          <p:nvPr/>
        </p:nvSpPr>
        <p:spPr>
          <a:xfrm rot="19338901">
            <a:off x="6253821" y="2915860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48EC3E6A-E373-4761-1570-13D3F12BC8D1}"/>
              </a:ext>
            </a:extLst>
          </p:cNvPr>
          <p:cNvSpPr/>
          <p:nvPr/>
        </p:nvSpPr>
        <p:spPr>
          <a:xfrm rot="19627707">
            <a:off x="6371516" y="212974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50CEF4BD-1F35-9902-3334-3E7F8F24E709}"/>
              </a:ext>
            </a:extLst>
          </p:cNvPr>
          <p:cNvSpPr/>
          <p:nvPr/>
        </p:nvSpPr>
        <p:spPr>
          <a:xfrm rot="18182221">
            <a:off x="8074153" y="401353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9235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46F7FF70-BA1D-D727-14E5-015DAC02DA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1175" y="768213"/>
            <a:ext cx="9709649" cy="532157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97B7416-2FE3-40E9-C260-908749A25AB8}"/>
              </a:ext>
            </a:extLst>
          </p:cNvPr>
          <p:cNvSpPr/>
          <p:nvPr/>
        </p:nvSpPr>
        <p:spPr>
          <a:xfrm>
            <a:off x="1174320" y="6110661"/>
            <a:ext cx="9110187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k: Enalapril docking IL-17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13D62194-43F5-C342-B2C4-1F233886882F}"/>
              </a:ext>
            </a:extLst>
          </p:cNvPr>
          <p:cNvSpPr/>
          <p:nvPr/>
        </p:nvSpPr>
        <p:spPr>
          <a:xfrm rot="4008981">
            <a:off x="8479573" y="162429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DF435F6E-5D43-7A98-696F-CE33AB682B51}"/>
              </a:ext>
            </a:extLst>
          </p:cNvPr>
          <p:cNvSpPr/>
          <p:nvPr/>
        </p:nvSpPr>
        <p:spPr>
          <a:xfrm rot="5400000">
            <a:off x="10465708" y="1514500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B56F9E4A-F06A-1E00-200C-424371CCDA12}"/>
              </a:ext>
            </a:extLst>
          </p:cNvPr>
          <p:cNvSpPr/>
          <p:nvPr/>
        </p:nvSpPr>
        <p:spPr>
          <a:xfrm rot="5400000">
            <a:off x="9193446" y="1070840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68700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iagram&#10;&#10;Description automatically generated">
            <a:extLst>
              <a:ext uri="{FF2B5EF4-FFF2-40B4-BE49-F238E27FC236}">
                <a16:creationId xmlns:a16="http://schemas.microsoft.com/office/drawing/2014/main" id="{0BC61F01-B8D8-9A9E-C242-90C78E8A17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992" y="756864"/>
            <a:ext cx="10860016" cy="534427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A6DC89D-3385-1542-C977-C15456EF5B06}"/>
              </a:ext>
            </a:extLst>
          </p:cNvPr>
          <p:cNvSpPr/>
          <p:nvPr/>
        </p:nvSpPr>
        <p:spPr>
          <a:xfrm>
            <a:off x="1304990" y="6145589"/>
            <a:ext cx="8981947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l: Ferulic docking IL-17F/IL-17R (3jvf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C3D17572-3AD9-FF9A-5634-A600D4915543}"/>
              </a:ext>
            </a:extLst>
          </p:cNvPr>
          <p:cNvSpPr/>
          <p:nvPr/>
        </p:nvSpPr>
        <p:spPr>
          <a:xfrm rot="5400000">
            <a:off x="8316896" y="112241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D1EBD00E-2455-C8AC-BCA2-20461DCAE750}"/>
              </a:ext>
            </a:extLst>
          </p:cNvPr>
          <p:cNvSpPr/>
          <p:nvPr/>
        </p:nvSpPr>
        <p:spPr>
          <a:xfrm rot="15795605">
            <a:off x="8073484" y="4890186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01962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34A6B24B-0231-ADEC-A1FD-3A5F430426D3}"/>
              </a:ext>
            </a:extLst>
          </p:cNvPr>
          <p:cNvGrpSpPr/>
          <p:nvPr/>
        </p:nvGrpSpPr>
        <p:grpSpPr>
          <a:xfrm>
            <a:off x="483423" y="942311"/>
            <a:ext cx="11246734" cy="4973379"/>
            <a:chOff x="483423" y="942311"/>
            <a:chExt cx="11246734" cy="4973379"/>
          </a:xfrm>
        </p:grpSpPr>
        <p:pic>
          <p:nvPicPr>
            <p:cNvPr id="3" name="Picture 2" descr="A diagram of a molecule&#10;&#10;Description automatically generated">
              <a:extLst>
                <a:ext uri="{FF2B5EF4-FFF2-40B4-BE49-F238E27FC236}">
                  <a16:creationId xmlns:a16="http://schemas.microsoft.com/office/drawing/2014/main" id="{91BC0DBE-2CB9-B246-B17F-C2449E2A827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100" r="53386"/>
            <a:stretch/>
          </p:blipFill>
          <p:spPr>
            <a:xfrm>
              <a:off x="6655815" y="942311"/>
              <a:ext cx="5074342" cy="4973378"/>
            </a:xfrm>
            <a:prstGeom prst="rect">
              <a:avLst/>
            </a:prstGeom>
          </p:spPr>
        </p:pic>
        <p:pic>
          <p:nvPicPr>
            <p:cNvPr id="5" name="Picture 4" descr="A close-up of a blue and green structure&#10;&#10;Description automatically generated">
              <a:extLst>
                <a:ext uri="{FF2B5EF4-FFF2-40B4-BE49-F238E27FC236}">
                  <a16:creationId xmlns:a16="http://schemas.microsoft.com/office/drawing/2014/main" id="{28133CDC-B9DA-F0CE-99E0-564F5CFDCB7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423" y="942311"/>
              <a:ext cx="6172392" cy="4973379"/>
            </a:xfrm>
            <a:prstGeom prst="rect">
              <a:avLst/>
            </a:prstGeom>
          </p:spPr>
        </p:pic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1FB81436-52EA-5B04-9F51-2344E698B6B4}"/>
              </a:ext>
            </a:extLst>
          </p:cNvPr>
          <p:cNvSpPr/>
          <p:nvPr/>
        </p:nvSpPr>
        <p:spPr>
          <a:xfrm>
            <a:off x="1236232" y="5930644"/>
            <a:ext cx="952055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m: Indirubin docking IL-17F/IL-17R (3jvf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7B974246-0EF8-6323-A288-D87B393A2A6E}"/>
              </a:ext>
            </a:extLst>
          </p:cNvPr>
          <p:cNvSpPr/>
          <p:nvPr/>
        </p:nvSpPr>
        <p:spPr>
          <a:xfrm rot="3546740">
            <a:off x="8680453" y="124360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89776F3B-65B0-20A1-B763-5E03AA9E8495}"/>
              </a:ext>
            </a:extLst>
          </p:cNvPr>
          <p:cNvSpPr/>
          <p:nvPr/>
        </p:nvSpPr>
        <p:spPr>
          <a:xfrm rot="3546740">
            <a:off x="10353181" y="115073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14387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BFB8F8B1-A575-CED0-56DE-577F3553B9E2}"/>
              </a:ext>
            </a:extLst>
          </p:cNvPr>
          <p:cNvGrpSpPr/>
          <p:nvPr/>
        </p:nvGrpSpPr>
        <p:grpSpPr>
          <a:xfrm>
            <a:off x="657726" y="586255"/>
            <a:ext cx="10876547" cy="5096996"/>
            <a:chOff x="764499" y="1229192"/>
            <a:chExt cx="10876547" cy="5096996"/>
          </a:xfrm>
        </p:grpSpPr>
        <p:pic>
          <p:nvPicPr>
            <p:cNvPr id="3" name="Picture 2" descr="A screenshot of a computer generated image&#10;&#10;Description automatically generated">
              <a:extLst>
                <a:ext uri="{FF2B5EF4-FFF2-40B4-BE49-F238E27FC236}">
                  <a16:creationId xmlns:a16="http://schemas.microsoft.com/office/drawing/2014/main" id="{3E6348F5-2A7B-DB0D-71C0-CF0E2C97E3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19"/>
            <a:stretch/>
          </p:blipFill>
          <p:spPr>
            <a:xfrm>
              <a:off x="764499" y="1229193"/>
              <a:ext cx="5810836" cy="5096995"/>
            </a:xfrm>
            <a:prstGeom prst="rect">
              <a:avLst/>
            </a:prstGeom>
          </p:spPr>
        </p:pic>
        <p:pic>
          <p:nvPicPr>
            <p:cNvPr id="5" name="Picture 4" descr="A screenshot of a computer&#10;&#10;Description automatically generated">
              <a:extLst>
                <a:ext uri="{FF2B5EF4-FFF2-40B4-BE49-F238E27FC236}">
                  <a16:creationId xmlns:a16="http://schemas.microsoft.com/office/drawing/2014/main" id="{9B8306A1-9B42-9546-DAB3-8FAB63D2572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256"/>
            <a:stretch/>
          </p:blipFill>
          <p:spPr>
            <a:xfrm>
              <a:off x="6575335" y="1229192"/>
              <a:ext cx="5065711" cy="5096996"/>
            </a:xfrm>
            <a:prstGeom prst="rect">
              <a:avLst/>
            </a:prstGeom>
          </p:spPr>
        </p:pic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220B07F7-9B19-391A-EAE4-15A73CF1FAD4}"/>
              </a:ext>
            </a:extLst>
          </p:cNvPr>
          <p:cNvSpPr/>
          <p:nvPr/>
        </p:nvSpPr>
        <p:spPr>
          <a:xfrm>
            <a:off x="861411" y="6071884"/>
            <a:ext cx="10213053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n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3jvf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1F3F8697-2E7F-F916-133F-66979AC7DD48}"/>
              </a:ext>
            </a:extLst>
          </p:cNvPr>
          <p:cNvSpPr/>
          <p:nvPr/>
        </p:nvSpPr>
        <p:spPr>
          <a:xfrm rot="15807345">
            <a:off x="9671110" y="343608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4432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1DCDC4C3-7AA5-FCA5-3644-8CC0828253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887" y="256726"/>
            <a:ext cx="10574226" cy="532521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C9D159A-33BA-65A4-81EE-891DF4BA6045}"/>
              </a:ext>
            </a:extLst>
          </p:cNvPr>
          <p:cNvSpPr/>
          <p:nvPr/>
        </p:nvSpPr>
        <p:spPr>
          <a:xfrm>
            <a:off x="1284253" y="5777957"/>
            <a:ext cx="9879628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o: Kaempferol docking IL-17F/IL-17R (3jvf)</a:t>
            </a:r>
          </a:p>
        </p:txBody>
      </p:sp>
    </p:spTree>
    <p:extLst>
      <p:ext uri="{BB962C8B-B14F-4D97-AF65-F5344CB8AC3E}">
        <p14:creationId xmlns:p14="http://schemas.microsoft.com/office/powerpoint/2010/main" val="393383054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215531C-0B5F-19A4-494C-7BF85C5510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FCFF5B1-853B-4D75-930D-819CEA0109A4}"/>
              </a:ext>
            </a:extLst>
          </p:cNvPr>
          <p:cNvSpPr/>
          <p:nvPr/>
        </p:nvSpPr>
        <p:spPr>
          <a:xfrm>
            <a:off x="112839" y="5987839"/>
            <a:ext cx="12252073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p: Methionine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ulfoximine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3jvf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AEF15CE-A52E-949C-2A28-AF276D8970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6421" y="453642"/>
            <a:ext cx="10193173" cy="5344271"/>
          </a:xfrm>
          <a:prstGeom prst="rect">
            <a:avLst/>
          </a:prstGeom>
        </p:spPr>
      </p:pic>
      <p:sp>
        <p:nvSpPr>
          <p:cNvPr id="6" name="Arrow: Right 5">
            <a:extLst>
              <a:ext uri="{FF2B5EF4-FFF2-40B4-BE49-F238E27FC236}">
                <a16:creationId xmlns:a16="http://schemas.microsoft.com/office/drawing/2014/main" id="{0063ECC3-263F-6E8E-018A-D7DF8340050A}"/>
              </a:ext>
            </a:extLst>
          </p:cNvPr>
          <p:cNvSpPr/>
          <p:nvPr/>
        </p:nvSpPr>
        <p:spPr>
          <a:xfrm rot="3546740">
            <a:off x="9605870" y="345883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54287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3CE367A-CB6D-7D55-B070-DBD78657D0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466" y="496100"/>
            <a:ext cx="10879068" cy="530616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55FBEF6-906B-6952-07DA-08FCA289DB7D}"/>
              </a:ext>
            </a:extLst>
          </p:cNvPr>
          <p:cNvSpPr/>
          <p:nvPr/>
        </p:nvSpPr>
        <p:spPr>
          <a:xfrm>
            <a:off x="963826" y="5802265"/>
            <a:ext cx="10264349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q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F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6BC43717-E987-E4F3-3DD8-3EA5602A8D88}"/>
              </a:ext>
            </a:extLst>
          </p:cNvPr>
          <p:cNvSpPr/>
          <p:nvPr/>
        </p:nvSpPr>
        <p:spPr>
          <a:xfrm rot="3546740">
            <a:off x="7843170" y="615643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1DFFFB27-AE16-8BB7-9C66-79472EC51D13}"/>
              </a:ext>
            </a:extLst>
          </p:cNvPr>
          <p:cNvSpPr/>
          <p:nvPr/>
        </p:nvSpPr>
        <p:spPr>
          <a:xfrm rot="3546740">
            <a:off x="8955875" y="367833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31162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structure&#10;&#10;AI-generated content may be incorrect.">
            <a:extLst>
              <a:ext uri="{FF2B5EF4-FFF2-40B4-BE49-F238E27FC236}">
                <a16:creationId xmlns:a16="http://schemas.microsoft.com/office/drawing/2014/main" id="{A8784509-5875-4E84-7E60-7375D964A2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913" y="799733"/>
            <a:ext cx="11098174" cy="525853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DBFD442-AE5A-1911-D14E-6F7CA4B06095}"/>
              </a:ext>
            </a:extLst>
          </p:cNvPr>
          <p:cNvSpPr/>
          <p:nvPr/>
        </p:nvSpPr>
        <p:spPr>
          <a:xfrm>
            <a:off x="851485" y="6058267"/>
            <a:ext cx="10136108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q: Nitazoxanide docking IL-17F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9D7DC97D-FCA4-9257-15D5-8CB4F324DF06}"/>
              </a:ext>
            </a:extLst>
          </p:cNvPr>
          <p:cNvSpPr/>
          <p:nvPr/>
        </p:nvSpPr>
        <p:spPr>
          <a:xfrm rot="3546740">
            <a:off x="10624254" y="1400354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9633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iagram&#10;&#10;Description automatically generated">
            <a:extLst>
              <a:ext uri="{FF2B5EF4-FFF2-40B4-BE49-F238E27FC236}">
                <a16:creationId xmlns:a16="http://schemas.microsoft.com/office/drawing/2014/main" id="{52EDD411-E781-DE1F-698A-16522B2BE3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571" y="351430"/>
            <a:ext cx="10802858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E16A2BB-B2BE-7E32-73AD-850000D2F540}"/>
              </a:ext>
            </a:extLst>
          </p:cNvPr>
          <p:cNvSpPr/>
          <p:nvPr/>
        </p:nvSpPr>
        <p:spPr>
          <a:xfrm>
            <a:off x="1527986" y="5934670"/>
            <a:ext cx="9136027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a Acacetin docking IL-17F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768A15EE-5CBC-8998-786F-80D23460266F}"/>
              </a:ext>
            </a:extLst>
          </p:cNvPr>
          <p:cNvSpPr/>
          <p:nvPr/>
        </p:nvSpPr>
        <p:spPr>
          <a:xfrm>
            <a:off x="6647379" y="3747246"/>
            <a:ext cx="161093" cy="218579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E36D43FC-1D6A-8948-07BB-D7D808A9FC15}"/>
              </a:ext>
            </a:extLst>
          </p:cNvPr>
          <p:cNvSpPr/>
          <p:nvPr/>
        </p:nvSpPr>
        <p:spPr>
          <a:xfrm rot="21245077">
            <a:off x="6986085" y="2393893"/>
            <a:ext cx="177754" cy="196835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7B4A891D-EB2C-1D5F-6855-AA39A8FE51EC}"/>
              </a:ext>
            </a:extLst>
          </p:cNvPr>
          <p:cNvSpPr/>
          <p:nvPr/>
        </p:nvSpPr>
        <p:spPr>
          <a:xfrm>
            <a:off x="9193658" y="3747246"/>
            <a:ext cx="161093" cy="21857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95419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5DD886-D80D-C542-E55D-8B2D5CDD8B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9D4763D-70F4-71F6-3575-AAF39AB1BF38}"/>
              </a:ext>
            </a:extLst>
          </p:cNvPr>
          <p:cNvSpPr/>
          <p:nvPr/>
        </p:nvSpPr>
        <p:spPr>
          <a:xfrm>
            <a:off x="1284427" y="5847906"/>
            <a:ext cx="9623148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r: Quercetin docking IL-17F/IL-17R (3jvf)</a:t>
            </a:r>
          </a:p>
        </p:txBody>
      </p:sp>
      <p:pic>
        <p:nvPicPr>
          <p:cNvPr id="5" name="Picture 4" descr="A close-up of a structure&#10;&#10;Description automatically generated">
            <a:extLst>
              <a:ext uri="{FF2B5EF4-FFF2-40B4-BE49-F238E27FC236}">
                <a16:creationId xmlns:a16="http://schemas.microsoft.com/office/drawing/2014/main" id="{E9A37B9D-8AA4-A02F-DD26-551DF1BF63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528" y="0"/>
            <a:ext cx="10164594" cy="5306165"/>
          </a:xfrm>
          <a:prstGeom prst="rect">
            <a:avLst/>
          </a:prstGeom>
        </p:spPr>
      </p:pic>
      <p:sp>
        <p:nvSpPr>
          <p:cNvPr id="6" name="Arrow: Right 5">
            <a:extLst>
              <a:ext uri="{FF2B5EF4-FFF2-40B4-BE49-F238E27FC236}">
                <a16:creationId xmlns:a16="http://schemas.microsoft.com/office/drawing/2014/main" id="{6B9591AD-A8C6-013E-2643-E97E6DCB5D75}"/>
              </a:ext>
            </a:extLst>
          </p:cNvPr>
          <p:cNvSpPr/>
          <p:nvPr/>
        </p:nvSpPr>
        <p:spPr>
          <a:xfrm rot="3546740">
            <a:off x="9870275" y="571576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26636A8E-BEAA-CE13-B165-759745B2A72E}"/>
              </a:ext>
            </a:extLst>
          </p:cNvPr>
          <p:cNvSpPr/>
          <p:nvPr/>
        </p:nvSpPr>
        <p:spPr>
          <a:xfrm rot="3546740">
            <a:off x="10454169" y="979200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E5415139-8B2F-1071-5E77-01B4C386F5DD}"/>
              </a:ext>
            </a:extLst>
          </p:cNvPr>
          <p:cNvSpPr/>
          <p:nvPr/>
        </p:nvSpPr>
        <p:spPr>
          <a:xfrm rot="3546740">
            <a:off x="8294862" y="268291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73375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612041C-DF8A-4ED6-AF1D-27B1369D465C}"/>
              </a:ext>
            </a:extLst>
          </p:cNvPr>
          <p:cNvSpPr/>
          <p:nvPr/>
        </p:nvSpPr>
        <p:spPr>
          <a:xfrm>
            <a:off x="1669149" y="6020239"/>
            <a:ext cx="8853706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s: Phytic docking IL-17F/IL-17R (3jvf)</a:t>
            </a:r>
          </a:p>
        </p:txBody>
      </p:sp>
      <p:pic>
        <p:nvPicPr>
          <p:cNvPr id="4" name="Picture 3" descr="A close-up of a diagram&#10;&#10;Description automatically generated">
            <a:extLst>
              <a:ext uri="{FF2B5EF4-FFF2-40B4-BE49-F238E27FC236}">
                <a16:creationId xmlns:a16="http://schemas.microsoft.com/office/drawing/2014/main" id="{78EBBBF9-FA32-55AD-2DE6-0E15B33187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93" y="695021"/>
            <a:ext cx="10621857" cy="5325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30796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Description automatically generated">
            <a:extLst>
              <a:ext uri="{FF2B5EF4-FFF2-40B4-BE49-F238E27FC236}">
                <a16:creationId xmlns:a16="http://schemas.microsoft.com/office/drawing/2014/main" id="{BD858976-6AB7-C56C-53D9-066B29E383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408" y="174585"/>
            <a:ext cx="10736173" cy="535379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F9A21227-2FB4-07C1-F7A1-41B1E629C89E}"/>
              </a:ext>
            </a:extLst>
          </p:cNvPr>
          <p:cNvSpPr/>
          <p:nvPr/>
        </p:nvSpPr>
        <p:spPr>
          <a:xfrm>
            <a:off x="1374195" y="5723691"/>
            <a:ext cx="944361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t: Quinapril docking IL-17F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68B95587-E381-CE0F-8500-91AB538AAD55}"/>
              </a:ext>
            </a:extLst>
          </p:cNvPr>
          <p:cNvSpPr/>
          <p:nvPr/>
        </p:nvSpPr>
        <p:spPr>
          <a:xfrm rot="15889974">
            <a:off x="8636384" y="366969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18284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65F90B-0B6C-6B72-67F8-A94A79975D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718" y="445052"/>
            <a:ext cx="10964805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2011AC8-BF90-F6CB-FF11-8FD5BA8B6F20}"/>
              </a:ext>
            </a:extLst>
          </p:cNvPr>
          <p:cNvSpPr/>
          <p:nvPr/>
        </p:nvSpPr>
        <p:spPr>
          <a:xfrm>
            <a:off x="1258783" y="5760085"/>
            <a:ext cx="9674444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u: Quisqualic docking IL-17F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0B9D31A6-C5A1-2B6D-B462-76C34B062572}"/>
              </a:ext>
            </a:extLst>
          </p:cNvPr>
          <p:cNvSpPr/>
          <p:nvPr/>
        </p:nvSpPr>
        <p:spPr>
          <a:xfrm rot="15889974">
            <a:off x="10350884" y="420309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6A09B577-7442-59CE-C505-7C19E11BEF8A}"/>
              </a:ext>
            </a:extLst>
          </p:cNvPr>
          <p:cNvSpPr/>
          <p:nvPr/>
        </p:nvSpPr>
        <p:spPr>
          <a:xfrm rot="15889974">
            <a:off x="9569834" y="387924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6D7A3510-7461-2FFA-5203-2642B71E235A}"/>
              </a:ext>
            </a:extLst>
          </p:cNvPr>
          <p:cNvSpPr/>
          <p:nvPr/>
        </p:nvSpPr>
        <p:spPr>
          <a:xfrm rot="15889974">
            <a:off x="8217284" y="429342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430F28F3-17F0-A731-428D-A0B9C3E1F48A}"/>
              </a:ext>
            </a:extLst>
          </p:cNvPr>
          <p:cNvSpPr/>
          <p:nvPr/>
        </p:nvSpPr>
        <p:spPr>
          <a:xfrm rot="5202779">
            <a:off x="6526597" y="1012186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DFA24D57-BCC2-9782-77EB-ADDD223F2369}"/>
              </a:ext>
            </a:extLst>
          </p:cNvPr>
          <p:cNvSpPr/>
          <p:nvPr/>
        </p:nvSpPr>
        <p:spPr>
          <a:xfrm rot="5166236">
            <a:off x="9949123" y="924438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06372F18-CA3B-06EF-2564-84A140C8E1C3}"/>
              </a:ext>
            </a:extLst>
          </p:cNvPr>
          <p:cNvSpPr/>
          <p:nvPr/>
        </p:nvSpPr>
        <p:spPr>
          <a:xfrm rot="15889974">
            <a:off x="7349851" y="420309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21823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model&#10;&#10;AI-generated content may be incorrect.">
            <a:extLst>
              <a:ext uri="{FF2B5EF4-FFF2-40B4-BE49-F238E27FC236}">
                <a16:creationId xmlns:a16="http://schemas.microsoft.com/office/drawing/2014/main" id="{EF637F16-AE7D-EEF5-EF8C-98AD8FDE1E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171" y="292901"/>
            <a:ext cx="10879068" cy="527758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E51D543B-564E-4047-35E0-DEAD59BDA133}"/>
              </a:ext>
            </a:extLst>
          </p:cNvPr>
          <p:cNvSpPr/>
          <p:nvPr/>
        </p:nvSpPr>
        <p:spPr>
          <a:xfrm>
            <a:off x="1027961" y="5760085"/>
            <a:ext cx="10136108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v: Remdesivir docking IL-17AF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3F9F08E2-99F2-CBC2-159D-702FDDF4A22B}"/>
              </a:ext>
            </a:extLst>
          </p:cNvPr>
          <p:cNvSpPr/>
          <p:nvPr/>
        </p:nvSpPr>
        <p:spPr>
          <a:xfrm rot="7149107">
            <a:off x="11225504" y="2846622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F87F02B4-0DEC-F8C2-EC65-BA9EA4B98592}"/>
              </a:ext>
            </a:extLst>
          </p:cNvPr>
          <p:cNvSpPr/>
          <p:nvPr/>
        </p:nvSpPr>
        <p:spPr>
          <a:xfrm rot="13325918">
            <a:off x="10647537" y="4264068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BA77A4FF-7E68-35C4-4B37-2DE8D234DC8D}"/>
              </a:ext>
            </a:extLst>
          </p:cNvPr>
          <p:cNvSpPr/>
          <p:nvPr/>
        </p:nvSpPr>
        <p:spPr>
          <a:xfrm rot="3546740">
            <a:off x="7828137" y="108753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96450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DCF9497-CCD7-AD78-8A71-DFD27A8D97DB}"/>
              </a:ext>
            </a:extLst>
          </p:cNvPr>
          <p:cNvSpPr/>
          <p:nvPr/>
        </p:nvSpPr>
        <p:spPr>
          <a:xfrm>
            <a:off x="801286" y="5760085"/>
            <a:ext cx="10589437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w: Thymoquinone docking IL-17F/IL-17R (3jvf)</a:t>
            </a:r>
          </a:p>
        </p:txBody>
      </p:sp>
      <p:pic>
        <p:nvPicPr>
          <p:cNvPr id="4" name="Picture 3" descr="A close-up of a diagram&#10;&#10;Description automatically generated">
            <a:extLst>
              <a:ext uri="{FF2B5EF4-FFF2-40B4-BE49-F238E27FC236}">
                <a16:creationId xmlns:a16="http://schemas.microsoft.com/office/drawing/2014/main" id="{1E80C9BE-ADC7-B626-8BE5-D1BCFB2216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877" y="174585"/>
            <a:ext cx="10450383" cy="5344271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800053F1-FC1F-A64E-6EE9-071377AE786C}"/>
              </a:ext>
            </a:extLst>
          </p:cNvPr>
          <p:cNvSpPr/>
          <p:nvPr/>
        </p:nvSpPr>
        <p:spPr>
          <a:xfrm rot="3431570">
            <a:off x="7721985" y="77409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CDB7E2D4-F0F4-6F9C-8AE3-561C398EE28A}"/>
              </a:ext>
            </a:extLst>
          </p:cNvPr>
          <p:cNvSpPr/>
          <p:nvPr/>
        </p:nvSpPr>
        <p:spPr>
          <a:xfrm rot="15889974">
            <a:off x="8712583" y="429834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9212E23F-A52D-AF5E-1726-5E191ED80EA5}"/>
              </a:ext>
            </a:extLst>
          </p:cNvPr>
          <p:cNvSpPr/>
          <p:nvPr/>
        </p:nvSpPr>
        <p:spPr>
          <a:xfrm rot="3431570">
            <a:off x="8997460" y="69548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1495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89355D2-9974-D5AF-B401-EBD4DED73B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426" y="471351"/>
            <a:ext cx="10145541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9DC77A5-9C17-DA33-C17C-EAF8A43E8744}"/>
              </a:ext>
            </a:extLst>
          </p:cNvPr>
          <p:cNvSpPr/>
          <p:nvPr/>
        </p:nvSpPr>
        <p:spPr>
          <a:xfrm>
            <a:off x="1181289" y="5887813"/>
            <a:ext cx="982942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x: </a:t>
            </a:r>
            <a:r>
              <a:rPr lang="en-US" sz="36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docking IL-17/IL-17R (3jvf)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5026FDC0-0E65-E5A6-2C65-277952B49C10}"/>
              </a:ext>
            </a:extLst>
          </p:cNvPr>
          <p:cNvSpPr/>
          <p:nvPr/>
        </p:nvSpPr>
        <p:spPr>
          <a:xfrm rot="14996686">
            <a:off x="8825570" y="3727505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9525620F-5F17-8A80-26AA-D392420EAEBE}"/>
              </a:ext>
            </a:extLst>
          </p:cNvPr>
          <p:cNvSpPr/>
          <p:nvPr/>
        </p:nvSpPr>
        <p:spPr>
          <a:xfrm rot="14996686">
            <a:off x="9366855" y="410062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9F99A42F-65D7-AE5E-0F2B-823AD68E36E8}"/>
              </a:ext>
            </a:extLst>
          </p:cNvPr>
          <p:cNvSpPr/>
          <p:nvPr/>
        </p:nvSpPr>
        <p:spPr>
          <a:xfrm rot="14996686">
            <a:off x="10640326" y="2981600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6845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1663D4C4-0623-F1B7-EA6C-C2859806F067}"/>
              </a:ext>
            </a:extLst>
          </p:cNvPr>
          <p:cNvSpPr/>
          <p:nvPr/>
        </p:nvSpPr>
        <p:spPr>
          <a:xfrm>
            <a:off x="1156091" y="5934670"/>
            <a:ext cx="9879821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b Aminopterin docking IL-17F/IL-17R (3jvf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FC4E961-CF57-B85E-6C7F-0DB8A343E6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7516" y="485173"/>
            <a:ext cx="11403016" cy="5268060"/>
          </a:xfrm>
          <a:prstGeom prst="rect">
            <a:avLst/>
          </a:prstGeom>
        </p:spPr>
      </p:pic>
      <p:sp>
        <p:nvSpPr>
          <p:cNvPr id="4" name="Arrow: Right 3">
            <a:extLst>
              <a:ext uri="{FF2B5EF4-FFF2-40B4-BE49-F238E27FC236}">
                <a16:creationId xmlns:a16="http://schemas.microsoft.com/office/drawing/2014/main" id="{54223B02-BC07-9F91-3A8F-041B17375B1F}"/>
              </a:ext>
            </a:extLst>
          </p:cNvPr>
          <p:cNvSpPr/>
          <p:nvPr/>
        </p:nvSpPr>
        <p:spPr>
          <a:xfrm rot="15750092">
            <a:off x="9729285" y="3668056"/>
            <a:ext cx="177754" cy="196835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60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">
            <a:extLst>
              <a:ext uri="{FF2B5EF4-FFF2-40B4-BE49-F238E27FC236}">
                <a16:creationId xmlns:a16="http://schemas.microsoft.com/office/drawing/2014/main" id="{B7862ED3-DF58-A800-1871-90A10F1BA2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597" y="410689"/>
            <a:ext cx="10602805" cy="528711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709943A-7A8A-CA8A-70B0-E48AA38D4A88}"/>
              </a:ext>
            </a:extLst>
          </p:cNvPr>
          <p:cNvSpPr/>
          <p:nvPr/>
        </p:nvSpPr>
        <p:spPr>
          <a:xfrm>
            <a:off x="1245860" y="6020239"/>
            <a:ext cx="9700284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c: Amygdalin docking IL-17F/IL-17R (3jvf)</a:t>
            </a: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CCD193E4-F168-5FA0-502D-6655A974A4EC}"/>
              </a:ext>
            </a:extLst>
          </p:cNvPr>
          <p:cNvSpPr/>
          <p:nvPr/>
        </p:nvSpPr>
        <p:spPr>
          <a:xfrm rot="5618854">
            <a:off x="7153572" y="225627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A68C86CA-9555-B810-70E9-257550DBE8FC}"/>
              </a:ext>
            </a:extLst>
          </p:cNvPr>
          <p:cNvSpPr/>
          <p:nvPr/>
        </p:nvSpPr>
        <p:spPr>
          <a:xfrm rot="15795605">
            <a:off x="10957363" y="3921862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744F5210-AEA7-78A4-EA06-3FB22823B3BB}"/>
              </a:ext>
            </a:extLst>
          </p:cNvPr>
          <p:cNvSpPr/>
          <p:nvPr/>
        </p:nvSpPr>
        <p:spPr>
          <a:xfrm rot="15795605">
            <a:off x="8058677" y="4483337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947DD67C-19A6-9A09-49A4-35206DA7E344}"/>
              </a:ext>
            </a:extLst>
          </p:cNvPr>
          <p:cNvSpPr/>
          <p:nvPr/>
        </p:nvSpPr>
        <p:spPr>
          <a:xfrm rot="5400000">
            <a:off x="8820676" y="1321994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940083D0-9D66-65E9-12BA-2229E68EF516}"/>
              </a:ext>
            </a:extLst>
          </p:cNvPr>
          <p:cNvSpPr/>
          <p:nvPr/>
        </p:nvSpPr>
        <p:spPr>
          <a:xfrm rot="15984853">
            <a:off x="7243669" y="365737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E8860593-E6E7-44A2-1882-CC2545055827}"/>
              </a:ext>
            </a:extLst>
          </p:cNvPr>
          <p:cNvSpPr/>
          <p:nvPr/>
        </p:nvSpPr>
        <p:spPr>
          <a:xfrm rot="15984853">
            <a:off x="7851631" y="3833699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300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Description automatically generated">
            <a:extLst>
              <a:ext uri="{FF2B5EF4-FFF2-40B4-BE49-F238E27FC236}">
                <a16:creationId xmlns:a16="http://schemas.microsoft.com/office/drawing/2014/main" id="{4EC95D36-3BAE-0754-3916-47A1C58331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1942" y="167676"/>
            <a:ext cx="10126488" cy="5325218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00C0AF9-7CC5-88B5-544A-8854046E333D}"/>
              </a:ext>
            </a:extLst>
          </p:cNvPr>
          <p:cNvSpPr/>
          <p:nvPr/>
        </p:nvSpPr>
        <p:spPr>
          <a:xfrm>
            <a:off x="1444580" y="5766994"/>
            <a:ext cx="934121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d: Apigenin docking IL-17F/IL-17R (3jvf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9029E3D8-012C-430E-A278-2A7DA8D0B693}"/>
              </a:ext>
            </a:extLst>
          </p:cNvPr>
          <p:cNvSpPr/>
          <p:nvPr/>
        </p:nvSpPr>
        <p:spPr>
          <a:xfrm rot="869215">
            <a:off x="7363450" y="1384563"/>
            <a:ext cx="176755" cy="166763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0263A4C9-DEB2-5281-F13A-0E39DC5B9C5D}"/>
              </a:ext>
            </a:extLst>
          </p:cNvPr>
          <p:cNvSpPr/>
          <p:nvPr/>
        </p:nvSpPr>
        <p:spPr>
          <a:xfrm rot="20440293">
            <a:off x="9120771" y="3019072"/>
            <a:ext cx="155798" cy="175914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B3BF85A6-B339-A91E-FD31-67C7B3B25523}"/>
              </a:ext>
            </a:extLst>
          </p:cNvPr>
          <p:cNvSpPr/>
          <p:nvPr/>
        </p:nvSpPr>
        <p:spPr>
          <a:xfrm rot="598847">
            <a:off x="7990723" y="828799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5381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64C78E9C-CF19-1DB7-0A67-5D2D5922E0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149" y="550115"/>
            <a:ext cx="10745700" cy="536332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C336D08-D8A2-2AE6-4198-80DDBC7C2A2C}"/>
              </a:ext>
            </a:extLst>
          </p:cNvPr>
          <p:cNvSpPr/>
          <p:nvPr/>
        </p:nvSpPr>
        <p:spPr>
          <a:xfrm>
            <a:off x="1379703" y="5969773"/>
            <a:ext cx="985417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e: Artemisinin docking IL-17F/IL-17R (3jvf)</a:t>
            </a:r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3A6ACBFD-90EA-D0C1-88EB-2D9B98055CAA}"/>
              </a:ext>
            </a:extLst>
          </p:cNvPr>
          <p:cNvSpPr/>
          <p:nvPr/>
        </p:nvSpPr>
        <p:spPr>
          <a:xfrm rot="2563834">
            <a:off x="6619918" y="1342507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38D14729-BE54-241B-2E66-B62A32A4E028}"/>
              </a:ext>
            </a:extLst>
          </p:cNvPr>
          <p:cNvSpPr/>
          <p:nvPr/>
        </p:nvSpPr>
        <p:spPr>
          <a:xfrm rot="2129788">
            <a:off x="6223784" y="2195263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1139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B2C8D747-E102-00B5-B8E2-9FC228722B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361" y="269258"/>
            <a:ext cx="10231278" cy="533474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10F6E44-2D94-398E-7376-C5907F8EC8D3}"/>
              </a:ext>
            </a:extLst>
          </p:cNvPr>
          <p:cNvSpPr/>
          <p:nvPr/>
        </p:nvSpPr>
        <p:spPr>
          <a:xfrm>
            <a:off x="829127" y="5766994"/>
            <a:ext cx="10572125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f: Bromopyruvate docking IL-17F/IL-17R (3jvf)</a:t>
            </a:r>
          </a:p>
        </p:txBody>
      </p:sp>
    </p:spTree>
    <p:extLst>
      <p:ext uri="{BB962C8B-B14F-4D97-AF65-F5344CB8AC3E}">
        <p14:creationId xmlns:p14="http://schemas.microsoft.com/office/powerpoint/2010/main" val="33225177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A603E43-F210-3FA2-E731-D40B377E1E62}"/>
              </a:ext>
            </a:extLst>
          </p:cNvPr>
          <p:cNvSpPr/>
          <p:nvPr/>
        </p:nvSpPr>
        <p:spPr>
          <a:xfrm>
            <a:off x="1064975" y="6096372"/>
            <a:ext cx="9392315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g: Calcitriol docking IL-17F/IL-17R (3jvf)</a:t>
            </a:r>
          </a:p>
        </p:txBody>
      </p:sp>
      <p:pic>
        <p:nvPicPr>
          <p:cNvPr id="6" name="Picture 5" descr="A close-up of a computer screen&#10;&#10;Description automatically generated">
            <a:extLst>
              <a:ext uri="{FF2B5EF4-FFF2-40B4-BE49-F238E27FC236}">
                <a16:creationId xmlns:a16="http://schemas.microsoft.com/office/drawing/2014/main" id="{22AF8F57-1495-018C-1FC7-9871EBE0FF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203" y="761628"/>
            <a:ext cx="10707594" cy="5334744"/>
          </a:xfrm>
          <a:prstGeom prst="rect">
            <a:avLst/>
          </a:prstGeom>
        </p:spPr>
      </p:pic>
      <p:sp>
        <p:nvSpPr>
          <p:cNvPr id="2" name="Arrow: Right 1">
            <a:extLst>
              <a:ext uri="{FF2B5EF4-FFF2-40B4-BE49-F238E27FC236}">
                <a16:creationId xmlns:a16="http://schemas.microsoft.com/office/drawing/2014/main" id="{8783EBDE-ECAF-4C79-E5E7-D8ADFA2210FC}"/>
              </a:ext>
            </a:extLst>
          </p:cNvPr>
          <p:cNvSpPr/>
          <p:nvPr/>
        </p:nvSpPr>
        <p:spPr>
          <a:xfrm rot="5400000">
            <a:off x="8740737" y="1875345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Arrow: Right 2">
            <a:extLst>
              <a:ext uri="{FF2B5EF4-FFF2-40B4-BE49-F238E27FC236}">
                <a16:creationId xmlns:a16="http://schemas.microsoft.com/office/drawing/2014/main" id="{A2C0BBA7-49EC-EABA-08E3-F9050767D58B}"/>
              </a:ext>
            </a:extLst>
          </p:cNvPr>
          <p:cNvSpPr/>
          <p:nvPr/>
        </p:nvSpPr>
        <p:spPr>
          <a:xfrm rot="1476651">
            <a:off x="7280093" y="2101083"/>
            <a:ext cx="166011" cy="170142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AA6CFCB2-AF8F-68E9-92F7-5A9F63F5476B}"/>
              </a:ext>
            </a:extLst>
          </p:cNvPr>
          <p:cNvSpPr/>
          <p:nvPr/>
        </p:nvSpPr>
        <p:spPr>
          <a:xfrm rot="15984853">
            <a:off x="8184572" y="4462761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53A15A4F-DFEB-2BCC-DA82-9B620358EB28}"/>
              </a:ext>
            </a:extLst>
          </p:cNvPr>
          <p:cNvSpPr/>
          <p:nvPr/>
        </p:nvSpPr>
        <p:spPr>
          <a:xfrm rot="15984853">
            <a:off x="9662190" y="4151903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B8A280AD-E5A9-D7F8-3E5B-E6D283E9B495}"/>
              </a:ext>
            </a:extLst>
          </p:cNvPr>
          <p:cNvSpPr/>
          <p:nvPr/>
        </p:nvSpPr>
        <p:spPr>
          <a:xfrm rot="15984853">
            <a:off x="7390987" y="3315162"/>
            <a:ext cx="166011" cy="170142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5665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model of a molecule&#10;&#10;AI-generated content may be incorrect.">
            <a:extLst>
              <a:ext uri="{FF2B5EF4-FFF2-40B4-BE49-F238E27FC236}">
                <a16:creationId xmlns:a16="http://schemas.microsoft.com/office/drawing/2014/main" id="{559C8C46-FA57-2C7F-5A17-5CA65CE8EC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598" y="717324"/>
            <a:ext cx="11332804" cy="5423352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E088565-45ED-0BC1-AB9A-9CBDADBCB48C}"/>
              </a:ext>
            </a:extLst>
          </p:cNvPr>
          <p:cNvSpPr/>
          <p:nvPr/>
        </p:nvSpPr>
        <p:spPr>
          <a:xfrm>
            <a:off x="879369" y="6110661"/>
            <a:ext cx="9700092" cy="646331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Fig. S3h: Candesartan docking IL-17/IL-17R (3jvf)</a:t>
            </a:r>
          </a:p>
        </p:txBody>
      </p:sp>
    </p:spTree>
    <p:extLst>
      <p:ext uri="{BB962C8B-B14F-4D97-AF65-F5344CB8AC3E}">
        <p14:creationId xmlns:p14="http://schemas.microsoft.com/office/powerpoint/2010/main" val="3756856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2</TotalTime>
  <Words>421</Words>
  <Application>Microsoft Office PowerPoint</Application>
  <PresentationFormat>Widescreen</PresentationFormat>
  <Paragraphs>79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deer mohamed adel mahmoud elesseily</dc:creator>
  <cp:lastModifiedBy>Hadeer mohamed adel mahmoud elesseily</cp:lastModifiedBy>
  <cp:revision>75</cp:revision>
  <dcterms:created xsi:type="dcterms:W3CDTF">2024-12-08T16:42:27Z</dcterms:created>
  <dcterms:modified xsi:type="dcterms:W3CDTF">2025-09-17T21:48:17Z</dcterms:modified>
</cp:coreProperties>
</file>